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9" d="100"/>
          <a:sy n="109" d="100"/>
        </p:scale>
        <p:origin x="63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3C63F-D6E8-4189-879D-519F08C59548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C70BC-C318-4134-8744-473D7CE580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79239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3C63F-D6E8-4189-879D-519F08C59548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C70BC-C318-4134-8744-473D7CE580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47543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3C63F-D6E8-4189-879D-519F08C59548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C70BC-C318-4134-8744-473D7CE580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02611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3C63F-D6E8-4189-879D-519F08C59548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C70BC-C318-4134-8744-473D7CE580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25407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3C63F-D6E8-4189-879D-519F08C59548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C70BC-C318-4134-8744-473D7CE580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02542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3C63F-D6E8-4189-879D-519F08C59548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C70BC-C318-4134-8744-473D7CE580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55625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3C63F-D6E8-4189-879D-519F08C59548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C70BC-C318-4134-8744-473D7CE580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40726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3C63F-D6E8-4189-879D-519F08C59548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C70BC-C318-4134-8744-473D7CE580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1749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3C63F-D6E8-4189-879D-519F08C59548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C70BC-C318-4134-8744-473D7CE580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5927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3C63F-D6E8-4189-879D-519F08C59548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C70BC-C318-4134-8744-473D7CE580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43456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3C63F-D6E8-4189-879D-519F08C59548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C70BC-C318-4134-8744-473D7CE580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7494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F3C63F-D6E8-4189-879D-519F08C59548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7C70BC-C318-4134-8744-473D7CE580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89306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9252" y="0"/>
            <a:ext cx="8853495" cy="6858000"/>
          </a:xfrm>
          <a:prstGeom prst="rect">
            <a:avLst/>
          </a:prstGeom>
        </p:spPr>
      </p:pic>
      <p:cxnSp>
        <p:nvCxnSpPr>
          <p:cNvPr id="6" name="直接连接符 5"/>
          <p:cNvCxnSpPr/>
          <p:nvPr/>
        </p:nvCxnSpPr>
        <p:spPr>
          <a:xfrm>
            <a:off x="3279530" y="2690447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>
            <a:off x="4671646" y="2702170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>
            <a:off x="6054969" y="2702170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>
            <a:off x="7473461" y="2687516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3376245" y="2259624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vehicle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4717804" y="2318184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SHP099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7211157" y="2324046"/>
            <a:ext cx="1890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SHP099+DrugB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059364" y="2277209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err="1" smtClean="0">
                <a:solidFill>
                  <a:srgbClr val="FF0000"/>
                </a:solidFill>
              </a:rPr>
              <a:t>DrugB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158262" y="334108"/>
            <a:ext cx="8968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AKT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6531904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9252" y="0"/>
            <a:ext cx="8853495" cy="685800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58262" y="334108"/>
            <a:ext cx="8968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P-AKT</a:t>
            </a:r>
            <a:endParaRPr lang="zh-CN" altLang="en-US" dirty="0"/>
          </a:p>
        </p:txBody>
      </p:sp>
      <p:cxnSp>
        <p:nvCxnSpPr>
          <p:cNvPr id="6" name="直接连接符 5"/>
          <p:cNvCxnSpPr/>
          <p:nvPr/>
        </p:nvCxnSpPr>
        <p:spPr>
          <a:xfrm>
            <a:off x="3859822" y="3305908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>
            <a:off x="5251938" y="3317631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>
            <a:off x="6635261" y="3317631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>
            <a:off x="8053753" y="3302977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3956537" y="2875085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vehicle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5298096" y="2933645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SHP099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7791449" y="2939507"/>
            <a:ext cx="1890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SHP099+DrugB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639656" y="2892670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err="1" smtClean="0">
                <a:solidFill>
                  <a:srgbClr val="FF0000"/>
                </a:solidFill>
              </a:rPr>
              <a:t>DrugB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962701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4510" y="0"/>
            <a:ext cx="9182979" cy="685800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58262" y="334108"/>
            <a:ext cx="8968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ERK</a:t>
            </a:r>
            <a:endParaRPr lang="zh-CN" altLang="en-US" dirty="0"/>
          </a:p>
        </p:txBody>
      </p:sp>
      <p:cxnSp>
        <p:nvCxnSpPr>
          <p:cNvPr id="6" name="直接连接符 5"/>
          <p:cNvCxnSpPr/>
          <p:nvPr/>
        </p:nvCxnSpPr>
        <p:spPr>
          <a:xfrm>
            <a:off x="3578466" y="545124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>
            <a:off x="4970582" y="556847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>
            <a:off x="6546305" y="542193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>
            <a:off x="8057117" y="508517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3675181" y="114301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vehicle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5016740" y="172861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SHP099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7794813" y="145047"/>
            <a:ext cx="1890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SHP099+DrugB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550700" y="117232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err="1" smtClean="0">
                <a:solidFill>
                  <a:srgbClr val="FF0000"/>
                </a:solidFill>
              </a:rPr>
              <a:t>DrugB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4" name="直接箭头连接符 13"/>
          <p:cNvCxnSpPr/>
          <p:nvPr/>
        </p:nvCxnSpPr>
        <p:spPr>
          <a:xfrm>
            <a:off x="2681654" y="483633"/>
            <a:ext cx="290146" cy="219807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本框 14"/>
          <p:cNvSpPr txBox="1"/>
          <p:nvPr/>
        </p:nvSpPr>
        <p:spPr>
          <a:xfrm>
            <a:off x="1332767" y="172861"/>
            <a:ext cx="163903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</a:rPr>
              <a:t>Sample loading error</a:t>
            </a:r>
            <a:endParaRPr lang="zh-CN" altLang="en-US" sz="1400" dirty="0">
              <a:solidFill>
                <a:srgbClr val="FF0000"/>
              </a:solidFill>
            </a:endParaRPr>
          </a:p>
        </p:txBody>
      </p:sp>
      <p:cxnSp>
        <p:nvCxnSpPr>
          <p:cNvPr id="17" name="直接箭头连接符 16"/>
          <p:cNvCxnSpPr/>
          <p:nvPr/>
        </p:nvCxnSpPr>
        <p:spPr>
          <a:xfrm flipV="1">
            <a:off x="2892669" y="1732085"/>
            <a:ext cx="254977" cy="32531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文本框 17"/>
          <p:cNvSpPr txBox="1"/>
          <p:nvPr/>
        </p:nvSpPr>
        <p:spPr>
          <a:xfrm>
            <a:off x="2338754" y="2154115"/>
            <a:ext cx="23035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</a:rPr>
              <a:t>Other experiment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801031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5472" y="0"/>
            <a:ext cx="9181403" cy="685800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58262" y="334108"/>
            <a:ext cx="8968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P-ERK</a:t>
            </a:r>
            <a:endParaRPr lang="zh-CN" altLang="en-US" dirty="0"/>
          </a:p>
        </p:txBody>
      </p:sp>
      <p:cxnSp>
        <p:nvCxnSpPr>
          <p:cNvPr id="6" name="直接连接符 5"/>
          <p:cNvCxnSpPr/>
          <p:nvPr/>
        </p:nvCxnSpPr>
        <p:spPr>
          <a:xfrm>
            <a:off x="3376243" y="993614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>
            <a:off x="4768359" y="1005337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>
            <a:off x="6151682" y="1005337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>
            <a:off x="7570174" y="990683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3472958" y="562791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vehicle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4814517" y="621351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SHP099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7307870" y="627213"/>
            <a:ext cx="1890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SHP099+DrugB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156077" y="580376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err="1" smtClean="0">
                <a:solidFill>
                  <a:srgbClr val="FF0000"/>
                </a:solidFill>
              </a:rPr>
              <a:t>DrugB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412261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9252" y="0"/>
            <a:ext cx="8853495" cy="685800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58262" y="334108"/>
            <a:ext cx="8968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SHP2</a:t>
            </a:r>
            <a:endParaRPr lang="zh-CN" altLang="en-US" dirty="0"/>
          </a:p>
        </p:txBody>
      </p:sp>
      <p:cxnSp>
        <p:nvCxnSpPr>
          <p:cNvPr id="6" name="直接连接符 5"/>
          <p:cNvCxnSpPr/>
          <p:nvPr/>
        </p:nvCxnSpPr>
        <p:spPr>
          <a:xfrm>
            <a:off x="3622427" y="3980040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>
            <a:off x="5014543" y="3991763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>
            <a:off x="6397866" y="3991763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>
            <a:off x="7816358" y="3977109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3719142" y="3549217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vehicle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5060701" y="3607777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SHP099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7554054" y="3613639"/>
            <a:ext cx="1890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SHP099+DrugB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402261" y="3566802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err="1" smtClean="0">
                <a:solidFill>
                  <a:srgbClr val="FF0000"/>
                </a:solidFill>
              </a:rPr>
              <a:t>DrugB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4" name="直接箭头连接符 13"/>
          <p:cNvCxnSpPr/>
          <p:nvPr/>
        </p:nvCxnSpPr>
        <p:spPr>
          <a:xfrm>
            <a:off x="2906953" y="3779315"/>
            <a:ext cx="290146" cy="219807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本框 14"/>
          <p:cNvSpPr txBox="1"/>
          <p:nvPr/>
        </p:nvSpPr>
        <p:spPr>
          <a:xfrm>
            <a:off x="1819087" y="3365998"/>
            <a:ext cx="163903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</a:rPr>
              <a:t>Sample loading error</a:t>
            </a:r>
            <a:endParaRPr lang="zh-CN" altLang="en-US" sz="14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8261331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9252" y="0"/>
            <a:ext cx="8853495" cy="685800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58262" y="334108"/>
            <a:ext cx="11314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P-SHP2</a:t>
            </a:r>
            <a:endParaRPr lang="zh-CN" altLang="en-US" dirty="0"/>
          </a:p>
        </p:txBody>
      </p:sp>
      <p:cxnSp>
        <p:nvCxnSpPr>
          <p:cNvPr id="6" name="直接连接符 5"/>
          <p:cNvCxnSpPr/>
          <p:nvPr/>
        </p:nvCxnSpPr>
        <p:spPr>
          <a:xfrm>
            <a:off x="3235566" y="2951340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>
            <a:off x="4627682" y="2963063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>
            <a:off x="6011005" y="2963063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>
            <a:off x="7429497" y="2948409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3332281" y="2520517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vehicle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4673840" y="2579077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SHP099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7167193" y="2584939"/>
            <a:ext cx="1890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SHP099+DrugB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015400" y="2538102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err="1" smtClean="0">
                <a:solidFill>
                  <a:srgbClr val="FF0000"/>
                </a:solidFill>
              </a:rPr>
              <a:t>DrugB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9942537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5298" y="0"/>
            <a:ext cx="9181403" cy="685800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58262" y="334108"/>
            <a:ext cx="11314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GAPDH</a:t>
            </a:r>
            <a:endParaRPr lang="zh-CN" altLang="en-US" dirty="0"/>
          </a:p>
        </p:txBody>
      </p:sp>
      <p:cxnSp>
        <p:nvCxnSpPr>
          <p:cNvPr id="6" name="直接连接符 5"/>
          <p:cNvCxnSpPr/>
          <p:nvPr/>
        </p:nvCxnSpPr>
        <p:spPr>
          <a:xfrm>
            <a:off x="3754312" y="4243810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>
            <a:off x="5146428" y="4255533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>
            <a:off x="6724295" y="4240879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>
            <a:off x="8142787" y="4226225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3851027" y="3812987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vehicle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5192586" y="3871547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SHP099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7880483" y="3862755"/>
            <a:ext cx="1890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SHP099+DrugB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728690" y="3815918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err="1" smtClean="0">
                <a:solidFill>
                  <a:srgbClr val="FF0000"/>
                </a:solidFill>
              </a:rPr>
              <a:t>DrugB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761719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43</Words>
  <Application>Microsoft Office PowerPoint</Application>
  <PresentationFormat>宽屏</PresentationFormat>
  <Paragraphs>38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1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袁云仓</dc:creator>
  <cp:lastModifiedBy>袁云仓</cp:lastModifiedBy>
  <cp:revision>3</cp:revision>
  <dcterms:created xsi:type="dcterms:W3CDTF">2021-07-20T02:12:49Z</dcterms:created>
  <dcterms:modified xsi:type="dcterms:W3CDTF">2021-07-20T02:33:50Z</dcterms:modified>
</cp:coreProperties>
</file>